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61" r:id="rId3"/>
    <p:sldId id="258" r:id="rId4"/>
    <p:sldId id="260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132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AEEE0-E17A-4164-BD1A-0DC2AA696DE8}" type="datetimeFigureOut">
              <a:rPr lang="en-IN" smtClean="0"/>
              <a:t>08-08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860FB-BFBC-452D-A703-AA02F54D6DE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649223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AEEE0-E17A-4164-BD1A-0DC2AA696DE8}" type="datetimeFigureOut">
              <a:rPr lang="en-IN" smtClean="0"/>
              <a:t>08-08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860FB-BFBC-452D-A703-AA02F54D6DE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831217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AEEE0-E17A-4164-BD1A-0DC2AA696DE8}" type="datetimeFigureOut">
              <a:rPr lang="en-IN" smtClean="0"/>
              <a:t>08-08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860FB-BFBC-452D-A703-AA02F54D6DE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67003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AEEE0-E17A-4164-BD1A-0DC2AA696DE8}" type="datetimeFigureOut">
              <a:rPr lang="en-IN" smtClean="0"/>
              <a:t>08-08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860FB-BFBC-452D-A703-AA02F54D6DE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7033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AEEE0-E17A-4164-BD1A-0DC2AA696DE8}" type="datetimeFigureOut">
              <a:rPr lang="en-IN" smtClean="0"/>
              <a:t>08-08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860FB-BFBC-452D-A703-AA02F54D6DE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73251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AEEE0-E17A-4164-BD1A-0DC2AA696DE8}" type="datetimeFigureOut">
              <a:rPr lang="en-IN" smtClean="0"/>
              <a:t>08-08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860FB-BFBC-452D-A703-AA02F54D6DE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41046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AEEE0-E17A-4164-BD1A-0DC2AA696DE8}" type="datetimeFigureOut">
              <a:rPr lang="en-IN" smtClean="0"/>
              <a:t>08-08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860FB-BFBC-452D-A703-AA02F54D6DE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44591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AEEE0-E17A-4164-BD1A-0DC2AA696DE8}" type="datetimeFigureOut">
              <a:rPr lang="en-IN" smtClean="0"/>
              <a:t>08-08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860FB-BFBC-452D-A703-AA02F54D6DE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215771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AEEE0-E17A-4164-BD1A-0DC2AA696DE8}" type="datetimeFigureOut">
              <a:rPr lang="en-IN" smtClean="0"/>
              <a:t>08-08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860FB-BFBC-452D-A703-AA02F54D6DE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421361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AEEE0-E17A-4164-BD1A-0DC2AA696DE8}" type="datetimeFigureOut">
              <a:rPr lang="en-IN" smtClean="0"/>
              <a:t>08-08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860FB-BFBC-452D-A703-AA02F54D6DE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545550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AEEE0-E17A-4164-BD1A-0DC2AA696DE8}" type="datetimeFigureOut">
              <a:rPr lang="en-IN" smtClean="0"/>
              <a:t>08-08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860FB-BFBC-452D-A703-AA02F54D6DE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520574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9AEEE0-E17A-4164-BD1A-0DC2AA696DE8}" type="datetimeFigureOut">
              <a:rPr lang="en-IN" smtClean="0"/>
              <a:t>08-08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D860FB-BFBC-452D-A703-AA02F54D6DE9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51019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microsoft.com/office/2007/relationships/hdphoto" Target="../media/hdphoto2.wdp"/><Relationship Id="rId4" Type="http://schemas.openxmlformats.org/officeDocument/2006/relationships/image" Target="../media/image5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8DD651D-DFBB-4590-866D-BA820FEDE2F3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1539" y="1185890"/>
            <a:ext cx="5234729" cy="3582099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FFB1FE9-B313-4D2A-8199-073462589520}"/>
              </a:ext>
            </a:extLst>
          </p:cNvPr>
          <p:cNvSpPr txBox="1"/>
          <p:nvPr/>
        </p:nvSpPr>
        <p:spPr>
          <a:xfrm>
            <a:off x="477078" y="5016618"/>
            <a:ext cx="7858539" cy="635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IN" sz="1600" b="1" kern="150" dirty="0">
                <a:latin typeface="Times New Roman" panose="02020603050405020304" pitchFamily="18" charset="0"/>
                <a:ea typeface="Noto Sans CJK SC Regular"/>
                <a:cs typeface="FreeSans"/>
              </a:rPr>
              <a:t>Supplementary Fig.1</a:t>
            </a:r>
            <a:r>
              <a:rPr lang="en-IN" sz="1600" kern="150" dirty="0">
                <a:latin typeface="Times New Roman" panose="02020603050405020304" pitchFamily="18" charset="0"/>
                <a:ea typeface="Noto Sans CJK SC Regular"/>
                <a:cs typeface="FreeSans"/>
              </a:rPr>
              <a:t>. </a:t>
            </a:r>
            <a:r>
              <a:rPr lang="en-IN" sz="1600" kern="150" dirty="0">
                <a:solidFill>
                  <a:srgbClr val="00000A"/>
                </a:solidFill>
                <a:latin typeface="Times New Roman" panose="02020603050405020304" pitchFamily="18" charset="0"/>
                <a:ea typeface="Noto Sans CJK SC Regular"/>
                <a:cs typeface="FreeSans"/>
              </a:rPr>
              <a:t>Benchmarking Universal Single-Copy Orthologs (BUSCO) analysis of Draft guava genome assembly</a:t>
            </a:r>
            <a:r>
              <a:rPr lang="en-IN" sz="1600" b="1" kern="150" dirty="0">
                <a:latin typeface="Times New Roman" panose="02020603050405020304" pitchFamily="18" charset="0"/>
                <a:ea typeface="Noto Sans CJK SC Regular"/>
                <a:cs typeface="FreeSans"/>
              </a:rPr>
              <a:t> </a:t>
            </a:r>
            <a:endParaRPr lang="en-IN" sz="1600" kern="150" dirty="0">
              <a:latin typeface="Liberation Serif"/>
              <a:ea typeface="Noto Sans CJK SC Regular"/>
              <a:cs typeface="FreeSans"/>
            </a:endParaRPr>
          </a:p>
        </p:txBody>
      </p:sp>
    </p:spTree>
    <p:extLst>
      <p:ext uri="{BB962C8B-B14F-4D97-AF65-F5344CB8AC3E}">
        <p14:creationId xmlns:p14="http://schemas.microsoft.com/office/powerpoint/2010/main" val="10452363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FA0236F-EF15-4D59-96F6-EDE2E737C164}"/>
              </a:ext>
            </a:extLst>
          </p:cNvPr>
          <p:cNvSpPr txBox="1"/>
          <p:nvPr/>
        </p:nvSpPr>
        <p:spPr>
          <a:xfrm>
            <a:off x="1007166" y="5652721"/>
            <a:ext cx="7858539" cy="64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IN" sz="1600" b="1" kern="150" dirty="0">
                <a:latin typeface="Times New Roman" panose="02020603050405020304" pitchFamily="18" charset="0"/>
                <a:ea typeface="Noto Sans CJK SC Regular"/>
                <a:cs typeface="FreeSans"/>
              </a:rPr>
              <a:t>Supplementary Fig.2</a:t>
            </a:r>
            <a:r>
              <a:rPr lang="en-IN" sz="1600" kern="150" dirty="0">
                <a:latin typeface="Times New Roman" panose="02020603050405020304" pitchFamily="18" charset="0"/>
                <a:ea typeface="Noto Sans CJK SC Regular"/>
                <a:cs typeface="FreeSans"/>
              </a:rPr>
              <a:t>. </a:t>
            </a:r>
            <a:r>
              <a:rPr lang="en-US" sz="1600" dirty="0"/>
              <a:t>KASP assay-ready SNP markers selection with Integrated Genome Viewer. </a:t>
            </a:r>
            <a:endParaRPr lang="en-IN" sz="1600" kern="150" dirty="0">
              <a:latin typeface="Liberation Serif"/>
              <a:ea typeface="Noto Sans CJK SC Regular"/>
              <a:cs typeface="FreeSans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1C1FA7F-05D1-41EF-9AA7-07AAF56E5D4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875" y="706582"/>
            <a:ext cx="8350830" cy="47609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26617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70DA9D3-FD5D-41DC-A1E8-28923154D43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lum bright="3000" contrast="7000"/>
          </a:blip>
          <a:srcRect l="668" t="1509" r="1383"/>
          <a:stretch/>
        </p:blipFill>
        <p:spPr>
          <a:xfrm>
            <a:off x="1258957" y="363567"/>
            <a:ext cx="6626086" cy="516755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9A7017C-922C-4A61-AFD3-11FA1C4E8BE9}"/>
              </a:ext>
            </a:extLst>
          </p:cNvPr>
          <p:cNvSpPr txBox="1"/>
          <p:nvPr/>
        </p:nvSpPr>
        <p:spPr>
          <a:xfrm>
            <a:off x="1007166" y="5652721"/>
            <a:ext cx="7858539" cy="3527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630555" indent="-630555" algn="just">
              <a:lnSpc>
                <a:spcPct val="115000"/>
              </a:lnSpc>
            </a:pPr>
            <a:r>
              <a:rPr lang="en-IN" sz="1600" b="1" kern="150" dirty="0">
                <a:latin typeface="Times New Roman" panose="02020603050405020304" pitchFamily="18" charset="0"/>
                <a:ea typeface="Noto Sans CJK SC Regular"/>
                <a:cs typeface="FreeSans"/>
              </a:rPr>
              <a:t>Supplementary Fig.3</a:t>
            </a:r>
            <a:r>
              <a:rPr lang="en-IN" sz="1600" kern="150" dirty="0">
                <a:latin typeface="Times New Roman" panose="02020603050405020304" pitchFamily="18" charset="0"/>
                <a:ea typeface="Noto Sans CJK SC Regular"/>
                <a:cs typeface="FreeSans"/>
              </a:rPr>
              <a:t>. Estimation of Delta k by </a:t>
            </a:r>
            <a:r>
              <a:rPr lang="en-IN" sz="1600" kern="150" dirty="0" err="1">
                <a:latin typeface="Times New Roman" panose="02020603050405020304" pitchFamily="18" charset="0"/>
                <a:ea typeface="Noto Sans CJK SC Regular"/>
                <a:cs typeface="FreeSans"/>
              </a:rPr>
              <a:t>Evanno’s</a:t>
            </a:r>
            <a:r>
              <a:rPr lang="en-IN" sz="1600" kern="150" dirty="0">
                <a:latin typeface="Times New Roman" panose="02020603050405020304" pitchFamily="18" charset="0"/>
                <a:ea typeface="Noto Sans CJK SC Regular"/>
                <a:cs typeface="FreeSans"/>
              </a:rPr>
              <a:t> correction for K 1-15.</a:t>
            </a:r>
            <a:endParaRPr lang="en-IN" sz="1600" kern="150" dirty="0">
              <a:latin typeface="Liberation Serif"/>
              <a:ea typeface="Noto Sans CJK SC Regular"/>
              <a:cs typeface="FreeSans"/>
            </a:endParaRPr>
          </a:p>
        </p:txBody>
      </p:sp>
    </p:spTree>
    <p:extLst>
      <p:ext uri="{BB962C8B-B14F-4D97-AF65-F5344CB8AC3E}">
        <p14:creationId xmlns:p14="http://schemas.microsoft.com/office/powerpoint/2010/main" val="11214540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EF0B8A8D-1311-4EE9-A36C-D46F6DCEC6BE}"/>
              </a:ext>
            </a:extLst>
          </p:cNvPr>
          <p:cNvSpPr txBox="1"/>
          <p:nvPr/>
        </p:nvSpPr>
        <p:spPr>
          <a:xfrm>
            <a:off x="238539" y="5870792"/>
            <a:ext cx="8786191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.4.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UCTURE analysis assuming Admixture model with assumed Structures as 3, 5, 10 &amp; 15 run on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) Allahabad Safeda2) L-49/Sardar guava 3)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ka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mulya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4) Shweta  5) Punjab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feda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6) Hisar Safeda7) Seedless 8)</a:t>
            </a:r>
            <a:r>
              <a:rPr lang="en-IN" sz="1400" dirty="0"/>
              <a:t>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NR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ihi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9) Lalit  10)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ka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iran 11) 17-16 12) Punjab Pink 13)Punjab Kiran 14) Hisar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rkha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5) HB-88 16) CISH-G1 17) CISH-G5/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alima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8) AC-14 19)AC-62 20) AC-107 21) Portugal 22) Purple Local</a:t>
            </a:r>
            <a:endParaRPr lang="en-IN" sz="1400" dirty="0"/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C08971CC-FC4A-4C17-862F-CF9A2C81DA96}"/>
              </a:ext>
            </a:extLst>
          </p:cNvPr>
          <p:cNvGrpSpPr/>
          <p:nvPr/>
        </p:nvGrpSpPr>
        <p:grpSpPr>
          <a:xfrm>
            <a:off x="914400" y="538650"/>
            <a:ext cx="7713644" cy="5381678"/>
            <a:chOff x="914400" y="538650"/>
            <a:chExt cx="7713644" cy="5381678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6BEBD684-D339-4104-964D-F5E698F97512}"/>
                </a:ext>
              </a:extLst>
            </p:cNvPr>
            <p:cNvGrpSpPr/>
            <p:nvPr/>
          </p:nvGrpSpPr>
          <p:grpSpPr>
            <a:xfrm>
              <a:off x="1556012" y="538650"/>
              <a:ext cx="7072032" cy="5381678"/>
              <a:chOff x="641614" y="671170"/>
              <a:chExt cx="7072032" cy="5381678"/>
            </a:xfrm>
          </p:grpSpPr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77BFB88D-E741-48FC-BD52-74F2A7151CC1}"/>
                  </a:ext>
                </a:extLst>
              </p:cNvPr>
              <p:cNvGrpSpPr/>
              <p:nvPr/>
            </p:nvGrpSpPr>
            <p:grpSpPr>
              <a:xfrm>
                <a:off x="641614" y="671170"/>
                <a:ext cx="4380967" cy="5203634"/>
                <a:chOff x="628354" y="671170"/>
                <a:chExt cx="4380967" cy="5203634"/>
              </a:xfrm>
            </p:grpSpPr>
            <p:pic>
              <p:nvPicPr>
                <p:cNvPr id="7" name="Picture 6">
                  <a:extLst>
                    <a:ext uri="{FF2B5EF4-FFF2-40B4-BE49-F238E27FC236}">
                      <a16:creationId xmlns:a16="http://schemas.microsoft.com/office/drawing/2014/main" id="{9ECD62AE-D59C-40A8-AB72-0FFDBAD2819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harpenSoften amount="30000"/>
                          </a14:imgEffect>
                          <a14:imgEffect>
                            <a14:brightnessContrast bright="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8794" r="55656"/>
                <a:stretch/>
              </p:blipFill>
              <p:spPr>
                <a:xfrm>
                  <a:off x="628354" y="3263624"/>
                  <a:ext cx="4380967" cy="1283320"/>
                </a:xfrm>
                <a:prstGeom prst="rect">
                  <a:avLst/>
                </a:prstGeom>
              </p:spPr>
            </p:pic>
            <p:pic>
              <p:nvPicPr>
                <p:cNvPr id="9" name="Picture 8">
                  <a:extLst>
                    <a:ext uri="{FF2B5EF4-FFF2-40B4-BE49-F238E27FC236}">
                      <a16:creationId xmlns:a16="http://schemas.microsoft.com/office/drawing/2014/main" id="{94E78CB7-61CE-4D52-B33D-AC501F8B026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harpenSoften amount="30000"/>
                          </a14:imgEffect>
                          <a14:imgEffect>
                            <a14:brightnessContrast bright="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6788" r="55839"/>
                <a:stretch/>
              </p:blipFill>
              <p:spPr>
                <a:xfrm>
                  <a:off x="628354" y="4539420"/>
                  <a:ext cx="4380967" cy="1335384"/>
                </a:xfrm>
                <a:prstGeom prst="rect">
                  <a:avLst/>
                </a:prstGeom>
              </p:spPr>
            </p:pic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E26CFECC-34BF-4760-A50B-4398E7AFE4F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sharpenSoften amount="30000"/>
                          </a14:imgEffect>
                          <a14:imgEffect>
                            <a14:brightnessContrast bright="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9136" r="56202"/>
                <a:stretch/>
              </p:blipFill>
              <p:spPr>
                <a:xfrm>
                  <a:off x="628354" y="671170"/>
                  <a:ext cx="4288202" cy="1317994"/>
                </a:xfrm>
                <a:prstGeom prst="rect">
                  <a:avLst/>
                </a:prstGeom>
              </p:spPr>
            </p:pic>
            <p:pic>
              <p:nvPicPr>
                <p:cNvPr id="8" name="Picture 7">
                  <a:extLst>
                    <a:ext uri="{FF2B5EF4-FFF2-40B4-BE49-F238E27FC236}">
                      <a16:creationId xmlns:a16="http://schemas.microsoft.com/office/drawing/2014/main" id="{6EBCC4C4-53F8-4A24-8BB9-788BB7E0D57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sharpenSoften amount="30000"/>
                          </a14:imgEffect>
                          <a14:imgEffect>
                            <a14:brightnessContrast bright="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8794" r="56245"/>
                <a:stretch/>
              </p:blipFill>
              <p:spPr>
                <a:xfrm>
                  <a:off x="628354" y="1987824"/>
                  <a:ext cx="4288202" cy="1283320"/>
                </a:xfrm>
                <a:prstGeom prst="rect">
                  <a:avLst/>
                </a:prstGeom>
              </p:spPr>
            </p:pic>
          </p:grp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175BB89E-835B-4717-917A-474E063B314B}"/>
                  </a:ext>
                </a:extLst>
              </p:cNvPr>
              <p:cNvSpPr txBox="1"/>
              <p:nvPr/>
            </p:nvSpPr>
            <p:spPr>
              <a:xfrm>
                <a:off x="5222238" y="712925"/>
                <a:ext cx="2491408" cy="5339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550" dirty="0"/>
                  <a:t>1.Allahabad </a:t>
                </a:r>
                <a:r>
                  <a:rPr lang="en-IN" sz="1550" dirty="0" err="1"/>
                  <a:t>Safeda</a:t>
                </a:r>
                <a:endParaRPr lang="en-IN" sz="1550" dirty="0"/>
              </a:p>
              <a:p>
                <a:r>
                  <a:rPr lang="en-IN" sz="1550" dirty="0"/>
                  <a:t>2.L-49/Sardar guava</a:t>
                </a:r>
              </a:p>
              <a:p>
                <a:r>
                  <a:rPr lang="en-IN" sz="1550" dirty="0"/>
                  <a:t>3.Arka </a:t>
                </a:r>
                <a:r>
                  <a:rPr lang="en-IN" sz="1550" dirty="0" err="1"/>
                  <a:t>Amulya</a:t>
                </a:r>
                <a:endParaRPr lang="en-IN" sz="1550" dirty="0"/>
              </a:p>
              <a:p>
                <a:r>
                  <a:rPr lang="en-IN" sz="1550" dirty="0"/>
                  <a:t>4.Shweta</a:t>
                </a:r>
              </a:p>
              <a:p>
                <a:r>
                  <a:rPr lang="en-IN" sz="1550" dirty="0"/>
                  <a:t>5.Punjab </a:t>
                </a:r>
                <a:r>
                  <a:rPr lang="en-IN" sz="1550" dirty="0" err="1"/>
                  <a:t>Safeda</a:t>
                </a:r>
                <a:endParaRPr lang="en-IN" sz="1550" dirty="0"/>
              </a:p>
              <a:p>
                <a:r>
                  <a:rPr lang="en-IN" sz="1550" dirty="0"/>
                  <a:t>6.Hisar </a:t>
                </a:r>
                <a:r>
                  <a:rPr lang="en-IN" sz="1550" dirty="0" err="1"/>
                  <a:t>Safeda</a:t>
                </a:r>
                <a:endParaRPr lang="en-IN" sz="1550" dirty="0"/>
              </a:p>
              <a:p>
                <a:r>
                  <a:rPr lang="en-IN" sz="1550" dirty="0"/>
                  <a:t>7.Seedless</a:t>
                </a:r>
              </a:p>
              <a:p>
                <a:r>
                  <a:rPr lang="en-IN" sz="1550" dirty="0"/>
                  <a:t>8.VNR-Bihi</a:t>
                </a:r>
              </a:p>
              <a:p>
                <a:r>
                  <a:rPr lang="en-IN" sz="1550" dirty="0"/>
                  <a:t>9.Lalit</a:t>
                </a:r>
              </a:p>
              <a:p>
                <a:r>
                  <a:rPr lang="en-IN" sz="1550" dirty="0"/>
                  <a:t>10.Arka Kiran</a:t>
                </a:r>
              </a:p>
              <a:p>
                <a:r>
                  <a:rPr lang="en-IN" sz="1550" dirty="0"/>
                  <a:t>11.17-16</a:t>
                </a:r>
              </a:p>
              <a:p>
                <a:r>
                  <a:rPr lang="en-IN" sz="1550" dirty="0"/>
                  <a:t>12.Punjab Pink</a:t>
                </a:r>
              </a:p>
              <a:p>
                <a:r>
                  <a:rPr lang="en-IN" sz="1550" dirty="0"/>
                  <a:t>13.Punjab Kiran</a:t>
                </a:r>
              </a:p>
              <a:p>
                <a:r>
                  <a:rPr lang="en-IN" sz="1550" dirty="0"/>
                  <a:t>14.Hisar </a:t>
                </a:r>
                <a:r>
                  <a:rPr lang="en-IN" sz="1550" dirty="0" err="1"/>
                  <a:t>Surkha</a:t>
                </a:r>
                <a:endParaRPr lang="en-IN" sz="1550" dirty="0"/>
              </a:p>
              <a:p>
                <a:r>
                  <a:rPr lang="en-IN" sz="1550" dirty="0"/>
                  <a:t>15.HB-88</a:t>
                </a:r>
              </a:p>
              <a:p>
                <a:r>
                  <a:rPr lang="en-IN" sz="1550" dirty="0"/>
                  <a:t>16.CISH-G1</a:t>
                </a:r>
              </a:p>
              <a:p>
                <a:r>
                  <a:rPr lang="en-IN" sz="1550" dirty="0"/>
                  <a:t>17.CISH-G5/</a:t>
                </a:r>
                <a:r>
                  <a:rPr lang="en-IN" sz="1550" dirty="0" err="1"/>
                  <a:t>Lalima</a:t>
                </a:r>
                <a:endParaRPr lang="en-IN" sz="1550" dirty="0"/>
              </a:p>
              <a:p>
                <a:r>
                  <a:rPr lang="en-IN" sz="1550" dirty="0"/>
                  <a:t>18.Apple Color-14</a:t>
                </a:r>
              </a:p>
              <a:p>
                <a:r>
                  <a:rPr lang="en-IN" sz="1550" dirty="0"/>
                  <a:t>19.Apple </a:t>
                </a:r>
                <a:r>
                  <a:rPr lang="en-IN" sz="1550" dirty="0" err="1"/>
                  <a:t>Color</a:t>
                </a:r>
                <a:r>
                  <a:rPr lang="en-IN" sz="1550" dirty="0"/>
                  <a:t>- 62</a:t>
                </a:r>
              </a:p>
              <a:p>
                <a:r>
                  <a:rPr lang="en-IN" sz="1550" dirty="0"/>
                  <a:t>20.Apple Color-107</a:t>
                </a:r>
              </a:p>
              <a:p>
                <a:r>
                  <a:rPr lang="en-IN" sz="1550" dirty="0"/>
                  <a:t>21.Portugal</a:t>
                </a:r>
              </a:p>
              <a:p>
                <a:r>
                  <a:rPr lang="en-IN" sz="1550" dirty="0"/>
                  <a:t>22.Purple Local</a:t>
                </a:r>
              </a:p>
            </p:txBody>
          </p:sp>
        </p:grp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5ABEB6B-5F2B-4C03-9B69-FC2FAAB04E15}"/>
                </a:ext>
              </a:extLst>
            </p:cNvPr>
            <p:cNvSpPr txBox="1"/>
            <p:nvPr/>
          </p:nvSpPr>
          <p:spPr>
            <a:xfrm>
              <a:off x="967404" y="940905"/>
              <a:ext cx="6228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600" b="1" dirty="0"/>
                <a:t>K=3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B3EB6DD-70E7-47C6-AD56-639FFF4D9F6B}"/>
                </a:ext>
              </a:extLst>
            </p:cNvPr>
            <p:cNvSpPr txBox="1"/>
            <p:nvPr/>
          </p:nvSpPr>
          <p:spPr>
            <a:xfrm>
              <a:off x="934276" y="2246238"/>
              <a:ext cx="6228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600" b="1" dirty="0"/>
                <a:t>K=5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D12D389-381A-4FE4-9384-95D7E9ADCFF0}"/>
                </a:ext>
              </a:extLst>
            </p:cNvPr>
            <p:cNvSpPr txBox="1"/>
            <p:nvPr/>
          </p:nvSpPr>
          <p:spPr>
            <a:xfrm>
              <a:off x="914400" y="3445572"/>
              <a:ext cx="6228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600" b="1" dirty="0"/>
                <a:t>K=10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BFE3EDB-9D2B-4515-B1F2-9857A75AA8BD}"/>
                </a:ext>
              </a:extLst>
            </p:cNvPr>
            <p:cNvSpPr txBox="1"/>
            <p:nvPr/>
          </p:nvSpPr>
          <p:spPr>
            <a:xfrm>
              <a:off x="927645" y="4737653"/>
              <a:ext cx="69574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600" b="1" dirty="0"/>
                <a:t>K=1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601245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44</TotalTime>
  <Words>245</Words>
  <Application>Microsoft Office PowerPoint</Application>
  <PresentationFormat>On-screen Show (4:3)</PresentationFormat>
  <Paragraphs>3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Liberation Serif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sidium guajava</dc:creator>
  <cp:lastModifiedBy>Mittal</cp:lastModifiedBy>
  <cp:revision>29</cp:revision>
  <dcterms:created xsi:type="dcterms:W3CDTF">2020-09-14T06:20:18Z</dcterms:created>
  <dcterms:modified xsi:type="dcterms:W3CDTF">2021-08-08T14:31:24Z</dcterms:modified>
</cp:coreProperties>
</file>